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8" r:id="rId3"/>
    <p:sldId id="259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94"/>
  </p:normalViewPr>
  <p:slideViewPr>
    <p:cSldViewPr snapToGrid="0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DB49D6-CF3B-1FF5-F218-AAA60838CB4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40BA112-52C4-39F7-8FEB-AC0DF80C8A7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500CB9-C1F9-B5D8-13CB-92592A2207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F225CF-46D1-1142-ABC5-1ACAECB9C238}" type="datetimeFigureOut">
              <a:rPr lang="en-US" smtClean="0"/>
              <a:t>9/2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D08D72-CF1F-F53D-886F-149F6EF824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77C8F9-4011-2207-8C2C-5E1C11BDF6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15204-5812-A848-8403-A1ABAA7EC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24679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A8F8D8-7B38-949F-5909-AB0057D754A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E7D6AE5-1BD6-BCB9-ACF9-437CC2299E6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A663C7-E40B-0FDB-6787-DC2CF23614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F225CF-46D1-1142-ABC5-1ACAECB9C238}" type="datetimeFigureOut">
              <a:rPr lang="en-US" smtClean="0"/>
              <a:t>9/2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166D98-F849-FD5E-10F4-D75152D10C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A1B2C5-5F3C-6645-C2CD-8585D88FB8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15204-5812-A848-8403-A1ABAA7EC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99538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DA24413-5023-0B2E-578D-2CC50BD8BF7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B7B0D8A-7B7E-BFE2-97A9-EF9A00F7A9A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74BD8D-EE7B-B99E-2A88-5F75C433AB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F225CF-46D1-1142-ABC5-1ACAECB9C238}" type="datetimeFigureOut">
              <a:rPr lang="en-US" smtClean="0"/>
              <a:t>9/2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1C5138-D421-C916-04DC-36739D1A96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020A5B-6A14-8A55-7EE9-CA0BD67D56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15204-5812-A848-8403-A1ABAA7EC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26579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72CAA7-15AD-8A5A-3512-C4B69E18F5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1F29B93-A29B-85FB-BAD5-34046D079B1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72B6C4-BD16-B6F4-6FA8-D12A1A7727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F225CF-46D1-1142-ABC5-1ACAECB9C238}" type="datetimeFigureOut">
              <a:rPr lang="en-US" smtClean="0"/>
              <a:t>9/2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A5578F-46E8-A37F-6F0D-35E853E27C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65432C-C121-2B41-4438-88D695199E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15204-5812-A848-8403-A1ABAA7EC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346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0F6715-47C1-0328-25BB-169E8E0CFB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6DD4EBE-0AFA-50D7-3ADE-6B2AE4AF46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F03B72-20F6-229F-6538-EEA1A33541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F225CF-46D1-1142-ABC5-1ACAECB9C238}" type="datetimeFigureOut">
              <a:rPr lang="en-US" smtClean="0"/>
              <a:t>9/2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28BAF1-B469-7B09-1095-76206E043F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4C5FCF-2273-8BE6-AAB3-B3C8501F7F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15204-5812-A848-8403-A1ABAA7EC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85466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521D23-2A2D-579C-6E87-2570B5D994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38CC68D-8666-B9E2-9097-2D94D72240B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4F46F21-510A-3835-41F5-56E8F86E05B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3CBE00B-C803-C5DD-AAD0-1A6AD31137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F225CF-46D1-1142-ABC5-1ACAECB9C238}" type="datetimeFigureOut">
              <a:rPr lang="en-US" smtClean="0"/>
              <a:t>9/25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A7BE6A1-1013-D6B4-EEE5-306683D122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AFAF394-6913-C4C8-702B-85BB5D9ACC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15204-5812-A848-8403-A1ABAA7EC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0480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54A6C2-8C9F-7081-D3E7-C00D0EE698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49A106-0114-C2A1-0034-90EA193A27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16B0FA7-6712-008A-BF3B-C751CBBF968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86EFBBD-1C22-9C96-3A7D-A789AA29259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269626E-4881-10AE-8D2E-BE6B5D7C3F7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0E98731-BF26-6617-DD1E-DF3FBED3E1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F225CF-46D1-1142-ABC5-1ACAECB9C238}" type="datetimeFigureOut">
              <a:rPr lang="en-US" smtClean="0"/>
              <a:t>9/25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036843A-4A83-622F-FA9F-2C7E613525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F883753-6521-09E1-B5E9-FE66323853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15204-5812-A848-8403-A1ABAA7EC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87198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8E7E50-EFD0-8CC4-C478-01EADC0D54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32D82F3-8D02-DF47-5727-B6EBBA9AF9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F225CF-46D1-1142-ABC5-1ACAECB9C238}" type="datetimeFigureOut">
              <a:rPr lang="en-US" smtClean="0"/>
              <a:t>9/25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444B2F2-4021-132C-F83E-18092823FD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976849C-9FB0-1C13-F028-1D5B62E4FD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15204-5812-A848-8403-A1ABAA7EC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44196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3EB96014-FD01-4F79-EC12-A5D610A67C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F225CF-46D1-1142-ABC5-1ACAECB9C238}" type="datetimeFigureOut">
              <a:rPr lang="en-US" smtClean="0"/>
              <a:t>9/25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7CC8263-1AD2-BB6F-04C2-D5E0BC4FD1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13D23CC-1E0E-EDAB-99D6-2F53880E9A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15204-5812-A848-8403-A1ABAA7EC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9277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896500-F546-538D-F076-452EF1EEF5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5DC8FBE-4674-EA6E-DBF9-A59041D976B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51EF9A8-D955-AE7B-117B-8E0D6675016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0ED2DAB-284A-C3AA-6F4D-E1DE2CD360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F225CF-46D1-1142-ABC5-1ACAECB9C238}" type="datetimeFigureOut">
              <a:rPr lang="en-US" smtClean="0"/>
              <a:t>9/25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2CEF050-DFBC-C0C1-D5B8-2AD6BAFAC6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E730269-5064-BCA1-CF39-73D90350B1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15204-5812-A848-8403-A1ABAA7EC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83834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06B28CF-4F0F-3B5A-E41D-6FE5152CF0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C3C3008-F04B-0E6A-12D4-4B4F53EC39E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A0F7B8A-D30E-3104-03C6-FA3C5C5EBB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A1289A7-081C-AC0A-1544-A6E3C20316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F225CF-46D1-1142-ABC5-1ACAECB9C238}" type="datetimeFigureOut">
              <a:rPr lang="en-US" smtClean="0"/>
              <a:t>9/25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C2E8ED6-8766-431A-6695-2C20A6687E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A8E7539-0F0E-F5D3-66A6-CA207B3ACF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615204-5812-A848-8403-A1ABAA7EC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80802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AD6EBB4-C9AD-90A6-AF58-CE2CF70414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DE7C1A9-6150-8B51-7B21-0D7C3D6CBB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AA4224-000C-E6C3-E9AE-E452F62E11F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2F225CF-46D1-1142-ABC5-1ACAECB9C238}" type="datetimeFigureOut">
              <a:rPr lang="en-US" smtClean="0"/>
              <a:t>9/2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900A8A-750D-1D52-1B82-2672D640DC1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2A3C0B5-7C31-E342-457B-E556E4CB8F3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4615204-5812-A848-8403-A1ABAA7ECC1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65395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4F4E9D9B-4F1C-4E5B-A506-F1C722D39D0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00284" y="129474"/>
            <a:ext cx="6389829" cy="383688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CD4F8EE0-9BFC-EFE0-7572-44F64EC9B1E8}"/>
              </a:ext>
            </a:extLst>
          </p:cNvPr>
          <p:cNvSpPr txBox="1"/>
          <p:nvPr/>
        </p:nvSpPr>
        <p:spPr>
          <a:xfrm>
            <a:off x="3289464" y="4085112"/>
            <a:ext cx="6200649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. Additional Seahorse parameters from CF MDMs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alculated parameters from the Seahorse assay in Figure 5G-L are displayed. *p&lt;0.05, **p&lt;0.01, ***p&lt;0.001, ****p&lt;0.0001 by mixed model linear regression for indicated comparisons. </a:t>
            </a:r>
          </a:p>
        </p:txBody>
      </p:sp>
    </p:spTree>
    <p:extLst>
      <p:ext uri="{BB962C8B-B14F-4D97-AF65-F5344CB8AC3E}">
        <p14:creationId xmlns:p14="http://schemas.microsoft.com/office/powerpoint/2010/main" val="228841671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DFC1F19-3ABC-B3BB-8773-F7BEBE90486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389E168E-1D8F-C719-0FEE-48A91E941890}"/>
              </a:ext>
            </a:extLst>
          </p:cNvPr>
          <p:cNvSpPr txBox="1"/>
          <p:nvPr/>
        </p:nvSpPr>
        <p:spPr>
          <a:xfrm>
            <a:off x="3289464" y="4085112"/>
            <a:ext cx="6388925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. Additional Seahorse parameters from nonCF MDMs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alculated parameters from the Seahorse assay in Figure 5M-R are displayed. *p&lt;0.05, **p&lt;0.01, ***p&lt;0.001, ****p&lt;0.0001 by mixed model linear regression for indicated comparisons. 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29D1077-4A1F-19BF-046C-88B9EA575B4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01189" y="130017"/>
            <a:ext cx="6388924" cy="38363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870651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821B293-590E-81DF-9CCE-D0CEA557915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EBD3ADA9-C82C-ABF3-CA3E-E9D9A46FED27}"/>
              </a:ext>
            </a:extLst>
          </p:cNvPr>
          <p:cNvSpPr txBox="1"/>
          <p:nvPr/>
        </p:nvSpPr>
        <p:spPr>
          <a:xfrm>
            <a:off x="1188521" y="3429000"/>
            <a:ext cx="10033661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3. Additional Seahorse parameters from THP-1s with acute injection of HSLs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alculated parameters from the Seahorse assay in Figure 6 are displayed. Points represent the means of technical replicates from individual experiments, with thick lines at the means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50938D01-14DD-B6D7-41EF-A8E519E2A9A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88521" y="1157293"/>
            <a:ext cx="9658155" cy="22717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672486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1</TotalTime>
  <Words>147</Words>
  <Application>Microsoft Macintosh PowerPoint</Application>
  <PresentationFormat>Widescreen</PresentationFormat>
  <Paragraphs>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Daniel Aridgides</dc:creator>
  <cp:lastModifiedBy>Daniel Aridgides</cp:lastModifiedBy>
  <cp:revision>6</cp:revision>
  <dcterms:created xsi:type="dcterms:W3CDTF">2025-08-12T18:43:50Z</dcterms:created>
  <dcterms:modified xsi:type="dcterms:W3CDTF">2025-09-25T16:28:19Z</dcterms:modified>
</cp:coreProperties>
</file>